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4" autoAdjust="0"/>
    <p:restoredTop sz="94660"/>
  </p:normalViewPr>
  <p:slideViewPr>
    <p:cSldViewPr snapToGrid="0" showGuides="1">
      <p:cViewPr varScale="1">
        <p:scale>
          <a:sx n="69" d="100"/>
          <a:sy n="69" d="100"/>
        </p:scale>
        <p:origin x="121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TTakeshima\Desktop\temp\SNG08\Figure1,%202,%20S1_20210930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TTakeshima\Desktop\temp\SNG08\Figure1,%202,%20S1_20210930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TTakeshima\Desktop\temp\SNG08\Figure1,%202,%20S1_20210930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TTakeshima\Desktop\temp\SNG08\Figure1,%202,%20S1_2021093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030833333333333"/>
          <c:y val="2.5664682539682539E-2"/>
          <c:w val="0.80428796296296301"/>
          <c:h val="0.7881979291193698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P9 分母調整した発生割合_Fig1S'!$J$22</c:f>
              <c:strCache>
                <c:ptCount val="1"/>
                <c:pt idx="0">
                  <c:v>検査のみ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22:$BJ$22</c:f>
              <c:numCache>
                <c:formatCode>General</c:formatCode>
                <c:ptCount val="52"/>
                <c:pt idx="0">
                  <c:v>20.366634598304188</c:v>
                </c:pt>
                <c:pt idx="1">
                  <c:v>24.675637600536074</c:v>
                </c:pt>
                <c:pt idx="2">
                  <c:v>32.185614261568794</c:v>
                </c:pt>
                <c:pt idx="3">
                  <c:v>36.318739590240199</c:v>
                </c:pt>
                <c:pt idx="4">
                  <c:v>46.180082530404633</c:v>
                </c:pt>
                <c:pt idx="5">
                  <c:v>49.498032234587789</c:v>
                </c:pt>
                <c:pt idx="6">
                  <c:v>66.91854110584201</c:v>
                </c:pt>
                <c:pt idx="7">
                  <c:v>80.386203586630913</c:v>
                </c:pt>
                <c:pt idx="8">
                  <c:v>88.239556477926456</c:v>
                </c:pt>
                <c:pt idx="9">
                  <c:v>114.14720441672371</c:v>
                </c:pt>
                <c:pt idx="10">
                  <c:v>115.47653134526661</c:v>
                </c:pt>
                <c:pt idx="11">
                  <c:v>132.54788769076498</c:v>
                </c:pt>
                <c:pt idx="12">
                  <c:v>176.1855540376915</c:v>
                </c:pt>
                <c:pt idx="13">
                  <c:v>225.58679401202022</c:v>
                </c:pt>
                <c:pt idx="14">
                  <c:v>279.43113108246524</c:v>
                </c:pt>
                <c:pt idx="15">
                  <c:v>366.75335954573558</c:v>
                </c:pt>
                <c:pt idx="16">
                  <c:v>405.23108223795947</c:v>
                </c:pt>
                <c:pt idx="17">
                  <c:v>330.27812922454564</c:v>
                </c:pt>
                <c:pt idx="18">
                  <c:v>520.37888997698485</c:v>
                </c:pt>
                <c:pt idx="19">
                  <c:v>724.15557919363596</c:v>
                </c:pt>
                <c:pt idx="20">
                  <c:v>837.50440016006291</c:v>
                </c:pt>
                <c:pt idx="21">
                  <c:v>982.59920579504887</c:v>
                </c:pt>
                <c:pt idx="22">
                  <c:v>916.06294402678702</c:v>
                </c:pt>
                <c:pt idx="23">
                  <c:v>735.49125111658088</c:v>
                </c:pt>
                <c:pt idx="24">
                  <c:v>644.26347349676064</c:v>
                </c:pt>
                <c:pt idx="25">
                  <c:v>544.40464165116759</c:v>
                </c:pt>
                <c:pt idx="26">
                  <c:v>455.97532413856447</c:v>
                </c:pt>
                <c:pt idx="27">
                  <c:v>373.92307510329158</c:v>
                </c:pt>
                <c:pt idx="28">
                  <c:v>281.71214185419643</c:v>
                </c:pt>
                <c:pt idx="29">
                  <c:v>217.71591030855961</c:v>
                </c:pt>
                <c:pt idx="30">
                  <c:v>154.16316134594334</c:v>
                </c:pt>
                <c:pt idx="31">
                  <c:v>119.39842856555434</c:v>
                </c:pt>
                <c:pt idx="32">
                  <c:v>110.40068194725804</c:v>
                </c:pt>
                <c:pt idx="33">
                  <c:v>106.4404595739438</c:v>
                </c:pt>
                <c:pt idx="34">
                  <c:v>67.67411835913785</c:v>
                </c:pt>
                <c:pt idx="35">
                  <c:v>63.507465741656262</c:v>
                </c:pt>
                <c:pt idx="36">
                  <c:v>48.440992920127449</c:v>
                </c:pt>
                <c:pt idx="37">
                  <c:v>37.970555242135717</c:v>
                </c:pt>
                <c:pt idx="38">
                  <c:v>30.762925079270492</c:v>
                </c:pt>
                <c:pt idx="39">
                  <c:v>23.569449307196656</c:v>
                </c:pt>
                <c:pt idx="40">
                  <c:v>18.213447915244931</c:v>
                </c:pt>
                <c:pt idx="41">
                  <c:v>17.102686262936761</c:v>
                </c:pt>
                <c:pt idx="42">
                  <c:v>15.094185740954863</c:v>
                </c:pt>
                <c:pt idx="43">
                  <c:v>12.648498969230449</c:v>
                </c:pt>
                <c:pt idx="44">
                  <c:v>11.247393808393417</c:v>
                </c:pt>
                <c:pt idx="45">
                  <c:v>9.5427820268777719</c:v>
                </c:pt>
                <c:pt idx="46">
                  <c:v>8.9187723568586499</c:v>
                </c:pt>
                <c:pt idx="47">
                  <c:v>7.836198638861374</c:v>
                </c:pt>
                <c:pt idx="48">
                  <c:v>7.5025239220942783</c:v>
                </c:pt>
                <c:pt idx="49">
                  <c:v>6.7111826564778427</c:v>
                </c:pt>
                <c:pt idx="50">
                  <c:v>8.3699556940199855</c:v>
                </c:pt>
                <c:pt idx="51">
                  <c:v>7.28947050442831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E9-45DB-B405-89B3C95B2A4C}"/>
            </c:ext>
          </c:extLst>
        </c:ser>
        <c:ser>
          <c:idx val="1"/>
          <c:order val="1"/>
          <c:tx>
            <c:strRef>
              <c:f>'P9 分母調整した発生割合_Fig1S'!$J$23</c:f>
              <c:strCache>
                <c:ptCount val="1"/>
                <c:pt idx="0">
                  <c:v>検査かつ処方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23:$BJ$23</c:f>
              <c:numCache>
                <c:formatCode>General</c:formatCode>
                <c:ptCount val="52"/>
                <c:pt idx="0">
                  <c:v>3.3416757976492195</c:v>
                </c:pt>
                <c:pt idx="1">
                  <c:v>3.7637822141943835</c:v>
                </c:pt>
                <c:pt idx="2">
                  <c:v>3.9572476551109177</c:v>
                </c:pt>
                <c:pt idx="3">
                  <c:v>3.2713247282250251</c:v>
                </c:pt>
                <c:pt idx="4">
                  <c:v>3.7846834554993269</c:v>
                </c:pt>
                <c:pt idx="5">
                  <c:v>3.5155846216085322</c:v>
                </c:pt>
                <c:pt idx="6">
                  <c:v>4.2676748640421982</c:v>
                </c:pt>
                <c:pt idx="7">
                  <c:v>5.7718553489095301</c:v>
                </c:pt>
                <c:pt idx="8">
                  <c:v>7.5504667806427603</c:v>
                </c:pt>
                <c:pt idx="9">
                  <c:v>9.0604124866476976</c:v>
                </c:pt>
                <c:pt idx="10">
                  <c:v>10.949456016682353</c:v>
                </c:pt>
                <c:pt idx="11">
                  <c:v>21.391668863262808</c:v>
                </c:pt>
                <c:pt idx="12">
                  <c:v>39.717024035761334</c:v>
                </c:pt>
                <c:pt idx="13">
                  <c:v>61.414011730023802</c:v>
                </c:pt>
                <c:pt idx="14">
                  <c:v>112.63605965742764</c:v>
                </c:pt>
                <c:pt idx="15">
                  <c:v>234.79976986790479</c:v>
                </c:pt>
                <c:pt idx="16">
                  <c:v>361.98079330540071</c:v>
                </c:pt>
                <c:pt idx="17">
                  <c:v>342.73785821937474</c:v>
                </c:pt>
                <c:pt idx="18">
                  <c:v>569.48275747782998</c:v>
                </c:pt>
                <c:pt idx="19">
                  <c:v>975.90229882851963</c:v>
                </c:pt>
                <c:pt idx="20">
                  <c:v>1081.03516185786</c:v>
                </c:pt>
                <c:pt idx="21">
                  <c:v>1124.1204148073721</c:v>
                </c:pt>
                <c:pt idx="22">
                  <c:v>963.31649079009367</c:v>
                </c:pt>
                <c:pt idx="23">
                  <c:v>665.42203836346096</c:v>
                </c:pt>
                <c:pt idx="24">
                  <c:v>473.72160317381963</c:v>
                </c:pt>
                <c:pt idx="25">
                  <c:v>366.11380823234487</c:v>
                </c:pt>
                <c:pt idx="26">
                  <c:v>257.81140194016956</c:v>
                </c:pt>
                <c:pt idx="27">
                  <c:v>176.3853731646528</c:v>
                </c:pt>
                <c:pt idx="28">
                  <c:v>106.17912404310066</c:v>
                </c:pt>
                <c:pt idx="29">
                  <c:v>70.641124301938362</c:v>
                </c:pt>
                <c:pt idx="30">
                  <c:v>42.408814809410622</c:v>
                </c:pt>
                <c:pt idx="31">
                  <c:v>27.220838841861038</c:v>
                </c:pt>
                <c:pt idx="32">
                  <c:v>30.058239546112997</c:v>
                </c:pt>
                <c:pt idx="33">
                  <c:v>25.263487553901129</c:v>
                </c:pt>
                <c:pt idx="34">
                  <c:v>12.515489803494747</c:v>
                </c:pt>
                <c:pt idx="35">
                  <c:v>7.7158603237526293</c:v>
                </c:pt>
                <c:pt idx="36">
                  <c:v>7.1527699253722599</c:v>
                </c:pt>
                <c:pt idx="37">
                  <c:v>4.1090380422351283</c:v>
                </c:pt>
                <c:pt idx="38">
                  <c:v>3.1004914657081861</c:v>
                </c:pt>
                <c:pt idx="39">
                  <c:v>2.4193301742054669</c:v>
                </c:pt>
                <c:pt idx="40">
                  <c:v>1.3998640001692009</c:v>
                </c:pt>
                <c:pt idx="41">
                  <c:v>1.5520231306223751</c:v>
                </c:pt>
                <c:pt idx="42">
                  <c:v>1.5976708697583271</c:v>
                </c:pt>
                <c:pt idx="43">
                  <c:v>1.2693834090983962</c:v>
                </c:pt>
                <c:pt idx="44">
                  <c:v>0.8370861427085764</c:v>
                </c:pt>
                <c:pt idx="45">
                  <c:v>0.68488866221610789</c:v>
                </c:pt>
                <c:pt idx="46">
                  <c:v>0.80664664661008267</c:v>
                </c:pt>
                <c:pt idx="47">
                  <c:v>0.84715660960663486</c:v>
                </c:pt>
                <c:pt idx="48">
                  <c:v>0.79134126561643514</c:v>
                </c:pt>
                <c:pt idx="49">
                  <c:v>0.4565430378556356</c:v>
                </c:pt>
                <c:pt idx="50">
                  <c:v>0.53263354416490827</c:v>
                </c:pt>
                <c:pt idx="51">
                  <c:v>0.654378354259744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5E9-45DB-B405-89B3C95B2A4C}"/>
            </c:ext>
          </c:extLst>
        </c:ser>
        <c:ser>
          <c:idx val="2"/>
          <c:order val="2"/>
          <c:tx>
            <c:strRef>
              <c:f>'P9 分母調整した発生割合_Fig1S'!$J$24</c:f>
              <c:strCache>
                <c:ptCount val="1"/>
                <c:pt idx="0">
                  <c:v>処方のみ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24:$BJ$24</c:f>
              <c:numCache>
                <c:formatCode>General</c:formatCode>
                <c:ptCount val="52"/>
                <c:pt idx="0">
                  <c:v>0.24622874298467931</c:v>
                </c:pt>
                <c:pt idx="1">
                  <c:v>0.3517553471209704</c:v>
                </c:pt>
                <c:pt idx="2">
                  <c:v>0.38693088183306751</c:v>
                </c:pt>
                <c:pt idx="3">
                  <c:v>0.38693088183306751</c:v>
                </c:pt>
                <c:pt idx="4">
                  <c:v>0.32985773236003313</c:v>
                </c:pt>
                <c:pt idx="5">
                  <c:v>0.36729988583969742</c:v>
                </c:pt>
                <c:pt idx="6">
                  <c:v>0.45475223961105393</c:v>
                </c:pt>
                <c:pt idx="7">
                  <c:v>0.5596950641366818</c:v>
                </c:pt>
                <c:pt idx="8">
                  <c:v>0.93945900035647256</c:v>
                </c:pt>
                <c:pt idx="9">
                  <c:v>1.0494686277970307</c:v>
                </c:pt>
                <c:pt idx="10">
                  <c:v>1.2768534971530541</c:v>
                </c:pt>
                <c:pt idx="11">
                  <c:v>2.2563575497636159</c:v>
                </c:pt>
                <c:pt idx="12">
                  <c:v>3.063188532118315</c:v>
                </c:pt>
                <c:pt idx="13">
                  <c:v>5.8389638251716329</c:v>
                </c:pt>
                <c:pt idx="14">
                  <c:v>10.261891513101045</c:v>
                </c:pt>
                <c:pt idx="15">
                  <c:v>18.600770987971909</c:v>
                </c:pt>
                <c:pt idx="16">
                  <c:v>33.110770912799623</c:v>
                </c:pt>
                <c:pt idx="17">
                  <c:v>28.142698035608486</c:v>
                </c:pt>
                <c:pt idx="18">
                  <c:v>42.649717953664791</c:v>
                </c:pt>
                <c:pt idx="19">
                  <c:v>68.937294622856129</c:v>
                </c:pt>
                <c:pt idx="20">
                  <c:v>79.734912378814627</c:v>
                </c:pt>
                <c:pt idx="21">
                  <c:v>79.451720676200068</c:v>
                </c:pt>
                <c:pt idx="22">
                  <c:v>67.016658052648026</c:v>
                </c:pt>
                <c:pt idx="23">
                  <c:v>45.823206846513884</c:v>
                </c:pt>
                <c:pt idx="24">
                  <c:v>33.630431214342892</c:v>
                </c:pt>
                <c:pt idx="25">
                  <c:v>25.620873694282601</c:v>
                </c:pt>
                <c:pt idx="26">
                  <c:v>18.073412496851503</c:v>
                </c:pt>
                <c:pt idx="27">
                  <c:v>12.785330303355009</c:v>
                </c:pt>
                <c:pt idx="28">
                  <c:v>7.8799382685983934</c:v>
                </c:pt>
                <c:pt idx="29">
                  <c:v>5.5316122945127795</c:v>
                </c:pt>
                <c:pt idx="30">
                  <c:v>2.4954996599514727</c:v>
                </c:pt>
                <c:pt idx="31">
                  <c:v>2.2759898697208225</c:v>
                </c:pt>
                <c:pt idx="32">
                  <c:v>2.0483908827487403</c:v>
                </c:pt>
                <c:pt idx="33">
                  <c:v>1.8663116931710744</c:v>
                </c:pt>
                <c:pt idx="34">
                  <c:v>0.99520762292849796</c:v>
                </c:pt>
                <c:pt idx="35">
                  <c:v>0.59352771721174069</c:v>
                </c:pt>
                <c:pt idx="36">
                  <c:v>0.68483967370585463</c:v>
                </c:pt>
                <c:pt idx="37">
                  <c:v>0.50221576071762675</c:v>
                </c:pt>
                <c:pt idx="38">
                  <c:v>0.34786001810384531</c:v>
                </c:pt>
                <c:pt idx="39">
                  <c:v>0.2434546087250784</c:v>
                </c:pt>
                <c:pt idx="40">
                  <c:v>6.0863652181269601E-2</c:v>
                </c:pt>
                <c:pt idx="41">
                  <c:v>0.152159130453174</c:v>
                </c:pt>
                <c:pt idx="42">
                  <c:v>7.6079565226587001E-2</c:v>
                </c:pt>
                <c:pt idx="43">
                  <c:v>0.12089365800937107</c:v>
                </c:pt>
                <c:pt idx="44">
                  <c:v>3.0439496098493689E-2</c:v>
                </c:pt>
                <c:pt idx="45">
                  <c:v>3.0439496098493689E-2</c:v>
                </c:pt>
                <c:pt idx="46">
                  <c:v>0.10653823634472789</c:v>
                </c:pt>
                <c:pt idx="47">
                  <c:v>4.5383389800355438E-2</c:v>
                </c:pt>
                <c:pt idx="48">
                  <c:v>0.16739911388039974</c:v>
                </c:pt>
                <c:pt idx="49">
                  <c:v>0.10652670883298164</c:v>
                </c:pt>
                <c:pt idx="50">
                  <c:v>9.1308607571127118E-2</c:v>
                </c:pt>
                <c:pt idx="51">
                  <c:v>0.167399113880399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5E9-45DB-B405-89B3C95B2A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overlap val="100"/>
        <c:axId val="887255912"/>
        <c:axId val="887257224"/>
      </c:barChart>
      <c:catAx>
        <c:axId val="887255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 Unicode MS" panose="020B0604020202020204" pitchFamily="34" charset="-128"/>
                    <a:ea typeface="+mn-ea"/>
                    <a:cs typeface="+mn-cs"/>
                  </a:defRPr>
                </a:pPr>
                <a:r>
                  <a:rPr lang="en-US" altLang="ja-JP" sz="900" baseline="0">
                    <a:solidFill>
                      <a:schemeClr val="tx1"/>
                    </a:solidFill>
                    <a:latin typeface="Arial Unicode MS" panose="020B0604020202020204" pitchFamily="34" charset="-128"/>
                  </a:rPr>
                  <a:t>Weeks in 2017/18</a:t>
                </a:r>
                <a:endParaRPr lang="ja-JP" altLang="en-US" sz="900" baseline="0">
                  <a:solidFill>
                    <a:schemeClr val="tx1"/>
                  </a:solidFill>
                  <a:latin typeface="Arial Unicode MS" panose="020B0604020202020204" pitchFamily="34" charset="-128"/>
                </a:endParaRPr>
              </a:p>
            </c:rich>
          </c:tx>
          <c:layout>
            <c:manualLayout>
              <c:xMode val="edge"/>
              <c:yMode val="edge"/>
              <c:x val="0.40983672839506174"/>
              <c:y val="0.919591295256011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 Unicode MS" panose="020B0604020202020204" pitchFamily="34" charset="-128"/>
                  <a:ea typeface="+mn-ea"/>
                  <a:cs typeface="+mn-cs"/>
                </a:defRPr>
              </a:pPr>
              <a:endParaRPr lang="ja-JP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887257224"/>
        <c:crosses val="autoZero"/>
        <c:auto val="1"/>
        <c:lblAlgn val="ctr"/>
        <c:lblOffset val="100"/>
        <c:noMultiLvlLbl val="0"/>
      </c:catAx>
      <c:valAx>
        <c:axId val="8872572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 Unicode MS" panose="020B0604020202020204" pitchFamily="34" charset="-128"/>
                    <a:ea typeface="+mn-ea"/>
                    <a:cs typeface="+mn-cs"/>
                  </a:defRPr>
                </a:pPr>
                <a:r>
                  <a:rPr lang="en-US" altLang="ja-JP" sz="900" baseline="0">
                    <a:solidFill>
                      <a:schemeClr val="tx1"/>
                    </a:solidFill>
                    <a:latin typeface="Arial Unicode MS" panose="020B0604020202020204" pitchFamily="34" charset="-128"/>
                  </a:rPr>
                  <a:t>Number of patients in 100,000 people</a:t>
                </a:r>
                <a:endParaRPr lang="ja-JP" altLang="en-US" sz="900" baseline="0">
                  <a:solidFill>
                    <a:schemeClr val="tx1"/>
                  </a:solidFill>
                  <a:latin typeface="Arial Unicode MS" panose="020B0604020202020204" pitchFamily="34" charset="-128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 Unicode MS" panose="020B0604020202020204" pitchFamily="34" charset="-128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887255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173796296296297"/>
          <c:y val="2.5664682539682539E-2"/>
          <c:w val="0.80284444444444447"/>
          <c:h val="0.7736406497704391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P9 分母調整した発生割合_Fig1S'!$J$34</c:f>
              <c:strCache>
                <c:ptCount val="1"/>
                <c:pt idx="0">
                  <c:v>検査のみ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34:$BJ$34</c:f>
              <c:numCache>
                <c:formatCode>General</c:formatCode>
                <c:ptCount val="52"/>
                <c:pt idx="0">
                  <c:v>10.37437341142407</c:v>
                </c:pt>
                <c:pt idx="1">
                  <c:v>26.879058384144187</c:v>
                </c:pt>
                <c:pt idx="2">
                  <c:v>41.81693916129732</c:v>
                </c:pt>
                <c:pt idx="3">
                  <c:v>57.92612016232092</c:v>
                </c:pt>
                <c:pt idx="4">
                  <c:v>68.968181089833053</c:v>
                </c:pt>
                <c:pt idx="5">
                  <c:v>67.65962672765265</c:v>
                </c:pt>
                <c:pt idx="6">
                  <c:v>81.736359683810704</c:v>
                </c:pt>
                <c:pt idx="7">
                  <c:v>94.078230416182791</c:v>
                </c:pt>
                <c:pt idx="8">
                  <c:v>96.527067741852036</c:v>
                </c:pt>
                <c:pt idx="9">
                  <c:v>117.99148818076753</c:v>
                </c:pt>
                <c:pt idx="10">
                  <c:v>124.36652796771034</c:v>
                </c:pt>
                <c:pt idx="11">
                  <c:v>133.46503343928984</c:v>
                </c:pt>
                <c:pt idx="12">
                  <c:v>175.42412702208009</c:v>
                </c:pt>
                <c:pt idx="13">
                  <c:v>202.63951424908873</c:v>
                </c:pt>
                <c:pt idx="14">
                  <c:v>252.6227112577001</c:v>
                </c:pt>
                <c:pt idx="15">
                  <c:v>370.22844465125053</c:v>
                </c:pt>
                <c:pt idx="16">
                  <c:v>406.69321691369339</c:v>
                </c:pt>
                <c:pt idx="17">
                  <c:v>338.74401470181346</c:v>
                </c:pt>
                <c:pt idx="18">
                  <c:v>681.56113891528275</c:v>
                </c:pt>
                <c:pt idx="19">
                  <c:v>739.24445810174393</c:v>
                </c:pt>
                <c:pt idx="20">
                  <c:v>856.01132480320314</c:v>
                </c:pt>
                <c:pt idx="21">
                  <c:v>801.09165463934301</c:v>
                </c:pt>
                <c:pt idx="22">
                  <c:v>688.6196084045157</c:v>
                </c:pt>
                <c:pt idx="23">
                  <c:v>494.71024766731591</c:v>
                </c:pt>
                <c:pt idx="24">
                  <c:v>425.66249446049397</c:v>
                </c:pt>
                <c:pt idx="25">
                  <c:v>334.21143144748078</c:v>
                </c:pt>
                <c:pt idx="26">
                  <c:v>276.4701676568713</c:v>
                </c:pt>
                <c:pt idx="27">
                  <c:v>221.10747184435994</c:v>
                </c:pt>
                <c:pt idx="28">
                  <c:v>174.14844217971697</c:v>
                </c:pt>
                <c:pt idx="29">
                  <c:v>144.17586380508152</c:v>
                </c:pt>
                <c:pt idx="30">
                  <c:v>113.22785688170339</c:v>
                </c:pt>
                <c:pt idx="31">
                  <c:v>113.50663094593538</c:v>
                </c:pt>
                <c:pt idx="32">
                  <c:v>160.14658019043841</c:v>
                </c:pt>
                <c:pt idx="33">
                  <c:v>243.97856171113185</c:v>
                </c:pt>
                <c:pt idx="34">
                  <c:v>148.86702598282039</c:v>
                </c:pt>
                <c:pt idx="35">
                  <c:v>167.55898510313082</c:v>
                </c:pt>
                <c:pt idx="36">
                  <c:v>125.29898728504882</c:v>
                </c:pt>
                <c:pt idx="37">
                  <c:v>102.45336736812592</c:v>
                </c:pt>
                <c:pt idx="38">
                  <c:v>79.590129774752072</c:v>
                </c:pt>
                <c:pt idx="39">
                  <c:v>61.176249772715273</c:v>
                </c:pt>
                <c:pt idx="40">
                  <c:v>46.849980350868961</c:v>
                </c:pt>
                <c:pt idx="41">
                  <c:v>40.559325712207681</c:v>
                </c:pt>
                <c:pt idx="42">
                  <c:v>34.16602635916265</c:v>
                </c:pt>
                <c:pt idx="43">
                  <c:v>28.532889507805471</c:v>
                </c:pt>
                <c:pt idx="44">
                  <c:v>27.641307381021335</c:v>
                </c:pt>
                <c:pt idx="45">
                  <c:v>22.887706748616395</c:v>
                </c:pt>
                <c:pt idx="46">
                  <c:v>20.290832329061843</c:v>
                </c:pt>
                <c:pt idx="47">
                  <c:v>16.366951431181132</c:v>
                </c:pt>
                <c:pt idx="48">
                  <c:v>16.189822124359548</c:v>
                </c:pt>
                <c:pt idx="49">
                  <c:v>14.396197515829918</c:v>
                </c:pt>
                <c:pt idx="50">
                  <c:v>15.96955243559275</c:v>
                </c:pt>
                <c:pt idx="51">
                  <c:v>17.8733118885057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D4-4A57-AA6F-74FE3F6AF52B}"/>
            </c:ext>
          </c:extLst>
        </c:ser>
        <c:ser>
          <c:idx val="1"/>
          <c:order val="1"/>
          <c:tx>
            <c:strRef>
              <c:f>'P9 分母調整した発生割合_Fig1S'!$J$35</c:f>
              <c:strCache>
                <c:ptCount val="1"/>
                <c:pt idx="0">
                  <c:v>検査かつ処方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35:$BJ$35</c:f>
              <c:numCache>
                <c:formatCode>General</c:formatCode>
                <c:ptCount val="52"/>
                <c:pt idx="0">
                  <c:v>1.0039716204603939</c:v>
                </c:pt>
                <c:pt idx="1">
                  <c:v>2.4642939774936941</c:v>
                </c:pt>
                <c:pt idx="2">
                  <c:v>2.616410889684663</c:v>
                </c:pt>
                <c:pt idx="3">
                  <c:v>3.2705136121058294</c:v>
                </c:pt>
                <c:pt idx="4">
                  <c:v>3.9832858909901394</c:v>
                </c:pt>
                <c:pt idx="5">
                  <c:v>2.9066551293256087</c:v>
                </c:pt>
                <c:pt idx="6">
                  <c:v>3.5610329856659293</c:v>
                </c:pt>
                <c:pt idx="7">
                  <c:v>4.108884214229918</c:v>
                </c:pt>
                <c:pt idx="8">
                  <c:v>4.1146156442224973</c:v>
                </c:pt>
                <c:pt idx="9">
                  <c:v>7.622660938564092</c:v>
                </c:pt>
                <c:pt idx="10">
                  <c:v>8.3377608669323795</c:v>
                </c:pt>
                <c:pt idx="11">
                  <c:v>11.943690292959705</c:v>
                </c:pt>
                <c:pt idx="12">
                  <c:v>20.959490676809949</c:v>
                </c:pt>
                <c:pt idx="13">
                  <c:v>36.22147102966602</c:v>
                </c:pt>
                <c:pt idx="14">
                  <c:v>72.077990210166647</c:v>
                </c:pt>
                <c:pt idx="15">
                  <c:v>208.38750587344381</c:v>
                </c:pt>
                <c:pt idx="16">
                  <c:v>330.5399310545132</c:v>
                </c:pt>
                <c:pt idx="17">
                  <c:v>454.96119750668453</c:v>
                </c:pt>
                <c:pt idx="18">
                  <c:v>1002.228646023344</c:v>
                </c:pt>
                <c:pt idx="19">
                  <c:v>1384.0648232660722</c:v>
                </c:pt>
                <c:pt idx="20">
                  <c:v>1376.8962630188892</c:v>
                </c:pt>
                <c:pt idx="21">
                  <c:v>996.68734584275899</c:v>
                </c:pt>
                <c:pt idx="22">
                  <c:v>597.87069765033573</c:v>
                </c:pt>
                <c:pt idx="23">
                  <c:v>280.01346233212058</c:v>
                </c:pt>
                <c:pt idx="24">
                  <c:v>180.06630655435873</c:v>
                </c:pt>
                <c:pt idx="25">
                  <c:v>112.03829576073825</c:v>
                </c:pt>
                <c:pt idx="26">
                  <c:v>76.319618142186755</c:v>
                </c:pt>
                <c:pt idx="27">
                  <c:v>52.228113412773602</c:v>
                </c:pt>
                <c:pt idx="28">
                  <c:v>45.69027012189197</c:v>
                </c:pt>
                <c:pt idx="29">
                  <c:v>37.286603974023564</c:v>
                </c:pt>
                <c:pt idx="30">
                  <c:v>32.746782078594848</c:v>
                </c:pt>
                <c:pt idx="31">
                  <c:v>37.177407017725521</c:v>
                </c:pt>
                <c:pt idx="32">
                  <c:v>58.749663253423847</c:v>
                </c:pt>
                <c:pt idx="33">
                  <c:v>55.57598216654484</c:v>
                </c:pt>
                <c:pt idx="34">
                  <c:v>25.862738205413816</c:v>
                </c:pt>
                <c:pt idx="35">
                  <c:v>21.525911449321434</c:v>
                </c:pt>
                <c:pt idx="36">
                  <c:v>21.980477699273045</c:v>
                </c:pt>
                <c:pt idx="37">
                  <c:v>13.563670361459353</c:v>
                </c:pt>
                <c:pt idx="38">
                  <c:v>10.054410388974537</c:v>
                </c:pt>
                <c:pt idx="39">
                  <c:v>7.1851300068625328</c:v>
                </c:pt>
                <c:pt idx="40">
                  <c:v>5.2495439641975237</c:v>
                </c:pt>
                <c:pt idx="41">
                  <c:v>3.7392003096937669</c:v>
                </c:pt>
                <c:pt idx="42">
                  <c:v>2.2141931245637601</c:v>
                </c:pt>
                <c:pt idx="43">
                  <c:v>2.942135620508783</c:v>
                </c:pt>
                <c:pt idx="44">
                  <c:v>2.9049781642474657</c:v>
                </c:pt>
                <c:pt idx="45">
                  <c:v>2.3034422817517779</c:v>
                </c:pt>
                <c:pt idx="46">
                  <c:v>1.9513237163884489</c:v>
                </c:pt>
                <c:pt idx="47">
                  <c:v>2.8178605051007657</c:v>
                </c:pt>
                <c:pt idx="48">
                  <c:v>2.8163053063754702</c:v>
                </c:pt>
                <c:pt idx="49">
                  <c:v>2.4387001256323906</c:v>
                </c:pt>
                <c:pt idx="50">
                  <c:v>3.0051078967470102</c:v>
                </c:pt>
                <c:pt idx="51">
                  <c:v>4.62566346410272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1D4-4A57-AA6F-74FE3F6AF52B}"/>
            </c:ext>
          </c:extLst>
        </c:ser>
        <c:ser>
          <c:idx val="2"/>
          <c:order val="2"/>
          <c:tx>
            <c:strRef>
              <c:f>'P9 分母調整した発生割合_Fig1S'!$J$36</c:f>
              <c:strCache>
                <c:ptCount val="1"/>
                <c:pt idx="0">
                  <c:v>処方のみ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36:$BJ$36</c:f>
              <c:numCache>
                <c:formatCode>General</c:formatCode>
                <c:ptCount val="52"/>
                <c:pt idx="0">
                  <c:v>0.10648183853367817</c:v>
                </c:pt>
                <c:pt idx="1">
                  <c:v>0.24338705950555004</c:v>
                </c:pt>
                <c:pt idx="2">
                  <c:v>0.30423382438193758</c:v>
                </c:pt>
                <c:pt idx="3">
                  <c:v>0.25859875072464694</c:v>
                </c:pt>
                <c:pt idx="4">
                  <c:v>0.28667587851822973</c:v>
                </c:pt>
                <c:pt idx="5">
                  <c:v>0.27392561428199452</c:v>
                </c:pt>
                <c:pt idx="6">
                  <c:v>0.57828740792865518</c:v>
                </c:pt>
                <c:pt idx="7">
                  <c:v>0.45654269046999091</c:v>
                </c:pt>
                <c:pt idx="8">
                  <c:v>0.529454218925689</c:v>
                </c:pt>
                <c:pt idx="9">
                  <c:v>0.74552971255417255</c:v>
                </c:pt>
                <c:pt idx="10">
                  <c:v>0.85203395720476871</c:v>
                </c:pt>
                <c:pt idx="11">
                  <c:v>1.1106871227847879</c:v>
                </c:pt>
                <c:pt idx="12">
                  <c:v>1.8916507831055911</c:v>
                </c:pt>
                <c:pt idx="13">
                  <c:v>2.8739958121775309</c:v>
                </c:pt>
                <c:pt idx="14">
                  <c:v>5.4438650833838951</c:v>
                </c:pt>
                <c:pt idx="15">
                  <c:v>14.324360079741981</c:v>
                </c:pt>
                <c:pt idx="16">
                  <c:v>29.926051631562864</c:v>
                </c:pt>
                <c:pt idx="17">
                  <c:v>36.881398363807051</c:v>
                </c:pt>
                <c:pt idx="18">
                  <c:v>78.382346651787714</c:v>
                </c:pt>
                <c:pt idx="19">
                  <c:v>117.28434238809245</c:v>
                </c:pt>
                <c:pt idx="20">
                  <c:v>118.62369122408417</c:v>
                </c:pt>
                <c:pt idx="21">
                  <c:v>88.155804486046662</c:v>
                </c:pt>
                <c:pt idx="22">
                  <c:v>53.559979715128527</c:v>
                </c:pt>
                <c:pt idx="23">
                  <c:v>23.909345508317255</c:v>
                </c:pt>
                <c:pt idx="24">
                  <c:v>15.838037788949009</c:v>
                </c:pt>
                <c:pt idx="25">
                  <c:v>10.018965207630879</c:v>
                </c:pt>
                <c:pt idx="26">
                  <c:v>7.1647597708291881</c:v>
                </c:pt>
                <c:pt idx="27">
                  <c:v>4.1794431996503603</c:v>
                </c:pt>
                <c:pt idx="28">
                  <c:v>4.4033419424887725</c:v>
                </c:pt>
                <c:pt idx="29">
                  <c:v>2.9703899883229341</c:v>
                </c:pt>
                <c:pt idx="30">
                  <c:v>2.4002876916247535</c:v>
                </c:pt>
                <c:pt idx="31">
                  <c:v>2.9250516929760439</c:v>
                </c:pt>
                <c:pt idx="32">
                  <c:v>4.1535734040259822</c:v>
                </c:pt>
                <c:pt idx="33">
                  <c:v>4.1389481455611019</c:v>
                </c:pt>
                <c:pt idx="34">
                  <c:v>1.5846197101686939</c:v>
                </c:pt>
                <c:pt idx="35">
                  <c:v>1.4956695966149771</c:v>
                </c:pt>
                <c:pt idx="36">
                  <c:v>1.6423038707929161</c:v>
                </c:pt>
                <c:pt idx="37">
                  <c:v>1.1584107660057175</c:v>
                </c:pt>
                <c:pt idx="38">
                  <c:v>0.83058172778485306</c:v>
                </c:pt>
                <c:pt idx="39">
                  <c:v>0.55721416379750255</c:v>
                </c:pt>
                <c:pt idx="40">
                  <c:v>0.45456944941375199</c:v>
                </c:pt>
                <c:pt idx="41">
                  <c:v>0.33726120440375151</c:v>
                </c:pt>
                <c:pt idx="42">
                  <c:v>0.26394355127250119</c:v>
                </c:pt>
                <c:pt idx="43">
                  <c:v>0.24760547301311536</c:v>
                </c:pt>
                <c:pt idx="44">
                  <c:v>0.35211856536332914</c:v>
                </c:pt>
                <c:pt idx="45">
                  <c:v>0.29343213780277427</c:v>
                </c:pt>
                <c:pt idx="46">
                  <c:v>0.29343213780277427</c:v>
                </c:pt>
                <c:pt idx="47">
                  <c:v>0.33580721045242284</c:v>
                </c:pt>
                <c:pt idx="48">
                  <c:v>0.39333872994070818</c:v>
                </c:pt>
                <c:pt idx="49">
                  <c:v>0.39333872994070818</c:v>
                </c:pt>
                <c:pt idx="50">
                  <c:v>0.58214132031224808</c:v>
                </c:pt>
                <c:pt idx="51">
                  <c:v>0.739476812288531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1D4-4A57-AA6F-74FE3F6AF5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overlap val="100"/>
        <c:axId val="887255912"/>
        <c:axId val="887257224"/>
      </c:barChart>
      <c:catAx>
        <c:axId val="887255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 Unicode MS" panose="020B0604020202020204" pitchFamily="34" charset="-128"/>
                    <a:ea typeface="+mn-ea"/>
                    <a:cs typeface="+mn-cs"/>
                  </a:defRPr>
                </a:pPr>
                <a:r>
                  <a:rPr lang="en-US" altLang="ja-JP" sz="900" baseline="0">
                    <a:solidFill>
                      <a:schemeClr val="tx1"/>
                    </a:solidFill>
                    <a:latin typeface="Arial Unicode MS" panose="020B0604020202020204" pitchFamily="34" charset="-128"/>
                  </a:rPr>
                  <a:t>Weeks in 2018/19</a:t>
                </a:r>
                <a:endParaRPr lang="ja-JP" altLang="en-US" sz="900" baseline="0">
                  <a:solidFill>
                    <a:schemeClr val="tx1"/>
                  </a:solidFill>
                  <a:latin typeface="Arial Unicode MS" panose="020B0604020202020204" pitchFamily="34" charset="-128"/>
                </a:endParaRPr>
              </a:p>
            </c:rich>
          </c:tx>
          <c:layout>
            <c:manualLayout>
              <c:xMode val="edge"/>
              <c:yMode val="edge"/>
              <c:x val="0.41838395061728395"/>
              <c:y val="0.921340046682329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 Unicode MS" panose="020B0604020202020204" pitchFamily="34" charset="-128"/>
                  <a:ea typeface="+mn-ea"/>
                  <a:cs typeface="+mn-cs"/>
                </a:defRPr>
              </a:pPr>
              <a:endParaRPr lang="ja-JP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887257224"/>
        <c:crosses val="autoZero"/>
        <c:auto val="1"/>
        <c:lblAlgn val="ctr"/>
        <c:lblOffset val="100"/>
        <c:noMultiLvlLbl val="0"/>
      </c:catAx>
      <c:valAx>
        <c:axId val="8872572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 Unicode MS" panose="020B0604020202020204" pitchFamily="34" charset="-128"/>
                    <a:ea typeface="+mn-ea"/>
                    <a:cs typeface="+mn-cs"/>
                  </a:defRPr>
                </a:pPr>
                <a:r>
                  <a:rPr lang="en-US" altLang="ja-JP" sz="900" baseline="0">
                    <a:solidFill>
                      <a:schemeClr val="tx1"/>
                    </a:solidFill>
                    <a:latin typeface="Arial Unicode MS" panose="020B0604020202020204" pitchFamily="34" charset="-128"/>
                  </a:rPr>
                  <a:t>Number of patients in 100,000 people</a:t>
                </a:r>
                <a:endParaRPr lang="ja-JP" altLang="en-US" sz="900" baseline="0">
                  <a:solidFill>
                    <a:schemeClr val="tx1"/>
                  </a:solidFill>
                  <a:latin typeface="Arial Unicode MS" panose="020B0604020202020204" pitchFamily="34" charset="-128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 Unicode MS" panose="020B0604020202020204" pitchFamily="34" charset="-128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887255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274197530864198"/>
          <c:y val="2.5664682539682539E-2"/>
          <c:w val="0.80183086419753069"/>
          <c:h val="0.7837198236716468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P9 分母調整した発生割合_Fig1S'!$J$46</c:f>
              <c:strCache>
                <c:ptCount val="1"/>
                <c:pt idx="0">
                  <c:v>Test alo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46:$BJ$46</c:f>
              <c:numCache>
                <c:formatCode>General</c:formatCode>
                <c:ptCount val="52"/>
                <c:pt idx="0">
                  <c:v>35.048292866555514</c:v>
                </c:pt>
                <c:pt idx="1">
                  <c:v>65.849261193627186</c:v>
                </c:pt>
                <c:pt idx="2">
                  <c:v>75.93272426699437</c:v>
                </c:pt>
                <c:pt idx="3">
                  <c:v>90.877014313326384</c:v>
                </c:pt>
                <c:pt idx="4">
                  <c:v>125.42642170778691</c:v>
                </c:pt>
                <c:pt idx="5">
                  <c:v>145.49731394418797</c:v>
                </c:pt>
                <c:pt idx="6">
                  <c:v>130.44532475139027</c:v>
                </c:pt>
                <c:pt idx="7">
                  <c:v>150.26797579085923</c:v>
                </c:pt>
                <c:pt idx="8">
                  <c:v>176.13017909021855</c:v>
                </c:pt>
                <c:pt idx="9">
                  <c:v>195.63037056388885</c:v>
                </c:pt>
                <c:pt idx="10">
                  <c:v>223.015158007389</c:v>
                </c:pt>
                <c:pt idx="11">
                  <c:v>250.39994545088916</c:v>
                </c:pt>
                <c:pt idx="12">
                  <c:v>296.70068276280676</c:v>
                </c:pt>
                <c:pt idx="13">
                  <c:v>375.13436164620157</c:v>
                </c:pt>
                <c:pt idx="14">
                  <c:v>474.42899595010158</c:v>
                </c:pt>
                <c:pt idx="15">
                  <c:v>549.63477753033987</c:v>
                </c:pt>
                <c:pt idx="16">
                  <c:v>573.9472668177491</c:v>
                </c:pt>
                <c:pt idx="17">
                  <c:v>323.09795208686029</c:v>
                </c:pt>
                <c:pt idx="18">
                  <c:v>545.83647057714154</c:v>
                </c:pt>
                <c:pt idx="19">
                  <c:v>440.36754139763349</c:v>
                </c:pt>
                <c:pt idx="20">
                  <c:v>500.97341796206666</c:v>
                </c:pt>
                <c:pt idx="21">
                  <c:v>533.39533125124728</c:v>
                </c:pt>
                <c:pt idx="22">
                  <c:v>466.53848930531149</c:v>
                </c:pt>
                <c:pt idx="23">
                  <c:v>405.32582218904764</c:v>
                </c:pt>
                <c:pt idx="24">
                  <c:v>403.13279515062493</c:v>
                </c:pt>
                <c:pt idx="25">
                  <c:v>318.50589358051513</c:v>
                </c:pt>
                <c:pt idx="26">
                  <c:v>241.99667505688387</c:v>
                </c:pt>
                <c:pt idx="27">
                  <c:v>146.47670666409226</c:v>
                </c:pt>
                <c:pt idx="28">
                  <c:v>71.922980707708746</c:v>
                </c:pt>
                <c:pt idx="29">
                  <c:v>53.87447391073993</c:v>
                </c:pt>
                <c:pt idx="30">
                  <c:v>36.947889295334718</c:v>
                </c:pt>
                <c:pt idx="31">
                  <c:v>25.668796586512698</c:v>
                </c:pt>
                <c:pt idx="32">
                  <c:v>15.761821645416125</c:v>
                </c:pt>
                <c:pt idx="33">
                  <c:v>9.4443303786299051</c:v>
                </c:pt>
                <c:pt idx="34">
                  <c:v>4.94551084016093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DA-49C3-B1C8-79955BAC4E66}"/>
            </c:ext>
          </c:extLst>
        </c:ser>
        <c:ser>
          <c:idx val="1"/>
          <c:order val="1"/>
          <c:tx>
            <c:strRef>
              <c:f>'P9 分母調整した発生割合_Fig1S'!$J$47</c:f>
              <c:strCache>
                <c:ptCount val="1"/>
                <c:pt idx="0">
                  <c:v>Test + prescriptio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47:$BJ$47</c:f>
              <c:numCache>
                <c:formatCode>General</c:formatCode>
                <c:ptCount val="52"/>
                <c:pt idx="0">
                  <c:v>10.461003032432412</c:v>
                </c:pt>
                <c:pt idx="1">
                  <c:v>15.573523311440736</c:v>
                </c:pt>
                <c:pt idx="2">
                  <c:v>13.512784368209688</c:v>
                </c:pt>
                <c:pt idx="3">
                  <c:v>13.858862664019481</c:v>
                </c:pt>
                <c:pt idx="4">
                  <c:v>16.219337951000721</c:v>
                </c:pt>
                <c:pt idx="5">
                  <c:v>16.406038429806717</c:v>
                </c:pt>
                <c:pt idx="6">
                  <c:v>12.233677408790616</c:v>
                </c:pt>
                <c:pt idx="7">
                  <c:v>15.933695672710554</c:v>
                </c:pt>
                <c:pt idx="8">
                  <c:v>20.03116655312018</c:v>
                </c:pt>
                <c:pt idx="9">
                  <c:v>22.455840652346893</c:v>
                </c:pt>
                <c:pt idx="10">
                  <c:v>38.297759092922611</c:v>
                </c:pt>
                <c:pt idx="11">
                  <c:v>67.682470633791695</c:v>
                </c:pt>
                <c:pt idx="12">
                  <c:v>114.0420709086721</c:v>
                </c:pt>
                <c:pt idx="13">
                  <c:v>207.93408216439298</c:v>
                </c:pt>
                <c:pt idx="14">
                  <c:v>345.10316594296279</c:v>
                </c:pt>
                <c:pt idx="15">
                  <c:v>480.77068993637062</c:v>
                </c:pt>
                <c:pt idx="16">
                  <c:v>547.98945138276883</c:v>
                </c:pt>
                <c:pt idx="17">
                  <c:v>349.69835398492773</c:v>
                </c:pt>
                <c:pt idx="18">
                  <c:v>463.90985579093785</c:v>
                </c:pt>
                <c:pt idx="19">
                  <c:v>386.69809690834916</c:v>
                </c:pt>
                <c:pt idx="20">
                  <c:v>398.6051058852749</c:v>
                </c:pt>
                <c:pt idx="21">
                  <c:v>298.6593745912291</c:v>
                </c:pt>
                <c:pt idx="22">
                  <c:v>185.14270603208894</c:v>
                </c:pt>
                <c:pt idx="23">
                  <c:v>149.23789108915489</c:v>
                </c:pt>
                <c:pt idx="24">
                  <c:v>118.91969247037773</c:v>
                </c:pt>
                <c:pt idx="25">
                  <c:v>91.658883011665338</c:v>
                </c:pt>
                <c:pt idx="26">
                  <c:v>55.596416255327057</c:v>
                </c:pt>
                <c:pt idx="27">
                  <c:v>20.5198129396633</c:v>
                </c:pt>
                <c:pt idx="28">
                  <c:v>6.7123863617702009</c:v>
                </c:pt>
                <c:pt idx="29">
                  <c:v>3.5873798845565212</c:v>
                </c:pt>
                <c:pt idx="30">
                  <c:v>1.7609074189678713</c:v>
                </c:pt>
                <c:pt idx="31">
                  <c:v>0.78170977796092134</c:v>
                </c:pt>
                <c:pt idx="32">
                  <c:v>0.41478478014252967</c:v>
                </c:pt>
                <c:pt idx="33">
                  <c:v>0.22334565084597752</c:v>
                </c:pt>
                <c:pt idx="34">
                  <c:v>0.143579346972414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DA-49C3-B1C8-79955BAC4E66}"/>
            </c:ext>
          </c:extLst>
        </c:ser>
        <c:ser>
          <c:idx val="2"/>
          <c:order val="2"/>
          <c:tx>
            <c:strRef>
              <c:f>'P9 分母調整した発生割合_Fig1S'!$J$48</c:f>
              <c:strCache>
                <c:ptCount val="1"/>
                <c:pt idx="0">
                  <c:v>Prescription alon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48:$BJ$48</c:f>
              <c:numCache>
                <c:formatCode>General</c:formatCode>
                <c:ptCount val="52"/>
                <c:pt idx="0">
                  <c:v>1.0539657190571003</c:v>
                </c:pt>
                <c:pt idx="1">
                  <c:v>1.7461223106766885</c:v>
                </c:pt>
                <c:pt idx="2">
                  <c:v>1.5888139943995094</c:v>
                </c:pt>
                <c:pt idx="3">
                  <c:v>1.4315056781223303</c:v>
                </c:pt>
                <c:pt idx="4">
                  <c:v>1.6719356076657781</c:v>
                </c:pt>
                <c:pt idx="5">
                  <c:v>1.7791577183955463</c:v>
                </c:pt>
                <c:pt idx="6">
                  <c:v>1.3225597198692556</c:v>
                </c:pt>
                <c:pt idx="7">
                  <c:v>1.6689444084064415</c:v>
                </c:pt>
                <c:pt idx="8">
                  <c:v>2.0516675672077747</c:v>
                </c:pt>
                <c:pt idx="9">
                  <c:v>2.4565996786578652</c:v>
                </c:pt>
                <c:pt idx="10">
                  <c:v>3.5589200472863944</c:v>
                </c:pt>
                <c:pt idx="11">
                  <c:v>6.4249530057205702</c:v>
                </c:pt>
                <c:pt idx="12">
                  <c:v>10.835015949112115</c:v>
                </c:pt>
                <c:pt idx="13">
                  <c:v>16.357417234104513</c:v>
                </c:pt>
                <c:pt idx="14">
                  <c:v>27.091972293985599</c:v>
                </c:pt>
                <c:pt idx="15">
                  <c:v>40.366399756427832</c:v>
                </c:pt>
                <c:pt idx="16">
                  <c:v>53.960308024223671</c:v>
                </c:pt>
                <c:pt idx="17">
                  <c:v>30.38229894211759</c:v>
                </c:pt>
                <c:pt idx="18">
                  <c:v>40.260074648155879</c:v>
                </c:pt>
                <c:pt idx="19">
                  <c:v>35.673079243622041</c:v>
                </c:pt>
                <c:pt idx="20">
                  <c:v>35.784957180317988</c:v>
                </c:pt>
                <c:pt idx="21">
                  <c:v>27.975446533001957</c:v>
                </c:pt>
                <c:pt idx="22">
                  <c:v>16.951938932040655</c:v>
                </c:pt>
                <c:pt idx="23">
                  <c:v>13.206184720428272</c:v>
                </c:pt>
                <c:pt idx="24">
                  <c:v>10.88509770895906</c:v>
                </c:pt>
                <c:pt idx="25">
                  <c:v>8.3441627663786715</c:v>
                </c:pt>
                <c:pt idx="26">
                  <c:v>6.0267982060549548</c:v>
                </c:pt>
                <c:pt idx="27">
                  <c:v>5.1339392125653323</c:v>
                </c:pt>
                <c:pt idx="28">
                  <c:v>5.3252661397416796</c:v>
                </c:pt>
                <c:pt idx="29">
                  <c:v>4.0497532918993615</c:v>
                </c:pt>
                <c:pt idx="30">
                  <c:v>3.3503990714875429</c:v>
                </c:pt>
                <c:pt idx="31">
                  <c:v>2.3291760731080511</c:v>
                </c:pt>
                <c:pt idx="32">
                  <c:v>1.1486347757793127</c:v>
                </c:pt>
                <c:pt idx="33">
                  <c:v>0.59027064866436907</c:v>
                </c:pt>
                <c:pt idx="34">
                  <c:v>0.398831519367816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2DA-49C3-B1C8-79955BAC4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overlap val="100"/>
        <c:axId val="887255912"/>
        <c:axId val="887257224"/>
      </c:barChart>
      <c:catAx>
        <c:axId val="887255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 Unicode MS" panose="020B0604020202020204" pitchFamily="34" charset="-128"/>
                    <a:ea typeface="+mn-ea"/>
                    <a:cs typeface="+mn-cs"/>
                  </a:defRPr>
                </a:pPr>
                <a:r>
                  <a:rPr lang="en-US" altLang="ja-JP" sz="900" baseline="0">
                    <a:solidFill>
                      <a:schemeClr val="tx1"/>
                    </a:solidFill>
                    <a:latin typeface="Arial Unicode MS" panose="020B0604020202020204" pitchFamily="34" charset="-128"/>
                  </a:rPr>
                  <a:t>Weeks in 2019/20</a:t>
                </a:r>
                <a:endParaRPr lang="ja-JP" altLang="en-US" sz="900" baseline="0">
                  <a:solidFill>
                    <a:schemeClr val="tx1"/>
                  </a:solidFill>
                  <a:latin typeface="Arial Unicode MS" panose="020B0604020202020204" pitchFamily="34" charset="-128"/>
                </a:endParaRPr>
              </a:p>
            </c:rich>
          </c:tx>
          <c:layout>
            <c:manualLayout>
              <c:xMode val="edge"/>
              <c:yMode val="edge"/>
              <c:x val="0.40320216049382718"/>
              <c:y val="0.916951282467742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 Unicode MS" panose="020B0604020202020204" pitchFamily="34" charset="-128"/>
                  <a:ea typeface="+mn-ea"/>
                  <a:cs typeface="+mn-cs"/>
                </a:defRPr>
              </a:pPr>
              <a:endParaRPr lang="ja-JP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887257224"/>
        <c:crosses val="autoZero"/>
        <c:auto val="1"/>
        <c:lblAlgn val="ctr"/>
        <c:lblOffset val="100"/>
        <c:noMultiLvlLbl val="0"/>
      </c:catAx>
      <c:valAx>
        <c:axId val="887257224"/>
        <c:scaling>
          <c:orientation val="minMax"/>
          <c:max val="25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 Unicode MS" panose="020B0604020202020204" pitchFamily="34" charset="-128"/>
                    <a:ea typeface="+mn-ea"/>
                    <a:cs typeface="+mn-cs"/>
                  </a:defRPr>
                </a:pPr>
                <a:r>
                  <a:rPr lang="en-US" altLang="ja-JP" sz="900" baseline="0">
                    <a:solidFill>
                      <a:schemeClr val="tx1"/>
                    </a:solidFill>
                    <a:latin typeface="Arial Unicode MS" panose="020B0604020202020204" pitchFamily="34" charset="-128"/>
                  </a:rPr>
                  <a:t>Number of patients in  100,000 people</a:t>
                </a:r>
                <a:endParaRPr lang="ja-JP" altLang="en-US" sz="900" baseline="0">
                  <a:solidFill>
                    <a:schemeClr val="tx1"/>
                  </a:solidFill>
                  <a:latin typeface="Arial Unicode MS" panose="020B0604020202020204" pitchFamily="34" charset="-128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 Unicode MS" panose="020B0604020202020204" pitchFamily="34" charset="-128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8872559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7155339506172831"/>
          <c:y val="8.5700716881422584E-2"/>
          <c:w val="0.38595370370370369"/>
          <c:h val="0.20748452380952384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 Unicode MS" panose="020B0604020202020204" pitchFamily="34" charset="-128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682191358024692"/>
          <c:y val="2.5664682539682539E-2"/>
          <c:w val="0.79767037037037036"/>
          <c:h val="0.7974363202332457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P9 分母調整した発生割合_Fig1S'!$J$10</c:f>
              <c:strCache>
                <c:ptCount val="1"/>
                <c:pt idx="0">
                  <c:v>検査のみ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10:$BJ$10</c:f>
              <c:numCache>
                <c:formatCode>General</c:formatCode>
                <c:ptCount val="52"/>
                <c:pt idx="0">
                  <c:v>6.4055323899165728</c:v>
                </c:pt>
                <c:pt idx="1">
                  <c:v>9.1418763234731664</c:v>
                </c:pt>
                <c:pt idx="2">
                  <c:v>12.023329405021398</c:v>
                </c:pt>
                <c:pt idx="3">
                  <c:v>21.103016093641006</c:v>
                </c:pt>
                <c:pt idx="4">
                  <c:v>32.844041332962782</c:v>
                </c:pt>
                <c:pt idx="5">
                  <c:v>43.776611367388846</c:v>
                </c:pt>
                <c:pt idx="6">
                  <c:v>64.640358061633734</c:v>
                </c:pt>
                <c:pt idx="7">
                  <c:v>76.479706384161602</c:v>
                </c:pt>
                <c:pt idx="8">
                  <c:v>79.504449036845088</c:v>
                </c:pt>
                <c:pt idx="9">
                  <c:v>119.07358064498776</c:v>
                </c:pt>
                <c:pt idx="10">
                  <c:v>150.17133767529472</c:v>
                </c:pt>
                <c:pt idx="11">
                  <c:v>161.05451811304687</c:v>
                </c:pt>
                <c:pt idx="12">
                  <c:v>214.39192796068892</c:v>
                </c:pt>
                <c:pt idx="13">
                  <c:v>254.47638259920589</c:v>
                </c:pt>
                <c:pt idx="14">
                  <c:v>283.59896407112609</c:v>
                </c:pt>
                <c:pt idx="15">
                  <c:v>333.90724178770068</c:v>
                </c:pt>
                <c:pt idx="16">
                  <c:v>313.05224909418229</c:v>
                </c:pt>
                <c:pt idx="17">
                  <c:v>252.9391899738572</c:v>
                </c:pt>
                <c:pt idx="18">
                  <c:v>347.90197395251658</c:v>
                </c:pt>
                <c:pt idx="19">
                  <c:v>398.48222053690296</c:v>
                </c:pt>
                <c:pt idx="20">
                  <c:v>495.01256444744024</c:v>
                </c:pt>
                <c:pt idx="21">
                  <c:v>586.89292344508431</c:v>
                </c:pt>
                <c:pt idx="22">
                  <c:v>543.13060754924061</c:v>
                </c:pt>
                <c:pt idx="23">
                  <c:v>445.83528929499425</c:v>
                </c:pt>
                <c:pt idx="24">
                  <c:v>405.44192612084873</c:v>
                </c:pt>
                <c:pt idx="25">
                  <c:v>333.92978044298292</c:v>
                </c:pt>
                <c:pt idx="26">
                  <c:v>321.33694306016253</c:v>
                </c:pt>
                <c:pt idx="27">
                  <c:v>289.71742025179833</c:v>
                </c:pt>
                <c:pt idx="28">
                  <c:v>247.91568235213623</c:v>
                </c:pt>
                <c:pt idx="29">
                  <c:v>217.59170977407629</c:v>
                </c:pt>
                <c:pt idx="30">
                  <c:v>185.83009912596233</c:v>
                </c:pt>
                <c:pt idx="31">
                  <c:v>175.59603737692083</c:v>
                </c:pt>
                <c:pt idx="32">
                  <c:v>192.61292155741606</c:v>
                </c:pt>
                <c:pt idx="33">
                  <c:v>210.55768110989302</c:v>
                </c:pt>
                <c:pt idx="34">
                  <c:v>164.79990336194936</c:v>
                </c:pt>
                <c:pt idx="35">
                  <c:v>139.28875285465557</c:v>
                </c:pt>
                <c:pt idx="36">
                  <c:v>102.72808928387985</c:v>
                </c:pt>
                <c:pt idx="37">
                  <c:v>75.175888927228996</c:v>
                </c:pt>
                <c:pt idx="38">
                  <c:v>51.333716299153345</c:v>
                </c:pt>
                <c:pt idx="39">
                  <c:v>36.464473472841689</c:v>
                </c:pt>
                <c:pt idx="40">
                  <c:v>27.896990056979028</c:v>
                </c:pt>
                <c:pt idx="41">
                  <c:v>22.665207151390767</c:v>
                </c:pt>
                <c:pt idx="42">
                  <c:v>17.38075529037712</c:v>
                </c:pt>
                <c:pt idx="43">
                  <c:v>14.378712246719159</c:v>
                </c:pt>
                <c:pt idx="44">
                  <c:v>12.789608653786523</c:v>
                </c:pt>
                <c:pt idx="45">
                  <c:v>10.821976553203982</c:v>
                </c:pt>
                <c:pt idx="46">
                  <c:v>11.647679309698441</c:v>
                </c:pt>
                <c:pt idx="47">
                  <c:v>11.167055125232668</c:v>
                </c:pt>
                <c:pt idx="48">
                  <c:v>11.454671086421886</c:v>
                </c:pt>
                <c:pt idx="49">
                  <c:v>9.959053509853744</c:v>
                </c:pt>
                <c:pt idx="50">
                  <c:v>11.067570066604249</c:v>
                </c:pt>
                <c:pt idx="51">
                  <c:v>13.6365131981212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E7-401C-BB7E-AC7C81D39D21}"/>
            </c:ext>
          </c:extLst>
        </c:ser>
        <c:ser>
          <c:idx val="1"/>
          <c:order val="1"/>
          <c:tx>
            <c:strRef>
              <c:f>'P9 分母調整した発生割合_Fig1S'!$J$11</c:f>
              <c:strCache>
                <c:ptCount val="1"/>
                <c:pt idx="0">
                  <c:v>検査かつ処方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11:$BJ$11</c:f>
              <c:numCache>
                <c:formatCode>General</c:formatCode>
                <c:ptCount val="52"/>
                <c:pt idx="0">
                  <c:v>0.87065488794982548</c:v>
                </c:pt>
                <c:pt idx="1">
                  <c:v>1.6583902627615721</c:v>
                </c:pt>
                <c:pt idx="2">
                  <c:v>1.5962006279080132</c:v>
                </c:pt>
                <c:pt idx="3">
                  <c:v>2.4875853941423585</c:v>
                </c:pt>
                <c:pt idx="4">
                  <c:v>4.5599607103925814</c:v>
                </c:pt>
                <c:pt idx="5">
                  <c:v>4.6570863156796642</c:v>
                </c:pt>
                <c:pt idx="6">
                  <c:v>5.94037232266695</c:v>
                </c:pt>
                <c:pt idx="7">
                  <c:v>7.65831971911767</c:v>
                </c:pt>
                <c:pt idx="8">
                  <c:v>8.9779693810060763</c:v>
                </c:pt>
                <c:pt idx="9">
                  <c:v>13.966058546545046</c:v>
                </c:pt>
                <c:pt idx="10">
                  <c:v>24.518191670601304</c:v>
                </c:pt>
                <c:pt idx="11">
                  <c:v>34.077182853569909</c:v>
                </c:pt>
                <c:pt idx="12">
                  <c:v>43.994195318992915</c:v>
                </c:pt>
                <c:pt idx="13">
                  <c:v>62.337619389149211</c:v>
                </c:pt>
                <c:pt idx="14">
                  <c:v>89.992703852903063</c:v>
                </c:pt>
                <c:pt idx="15">
                  <c:v>179.36533854742598</c:v>
                </c:pt>
                <c:pt idx="16">
                  <c:v>212.70439029633104</c:v>
                </c:pt>
                <c:pt idx="17">
                  <c:v>213.45469591081641</c:v>
                </c:pt>
                <c:pt idx="18">
                  <c:v>337.4221271939208</c:v>
                </c:pt>
                <c:pt idx="19">
                  <c:v>516.01359858300896</c:v>
                </c:pt>
                <c:pt idx="20">
                  <c:v>759.77855484360123</c:v>
                </c:pt>
                <c:pt idx="21">
                  <c:v>844.02221176006208</c:v>
                </c:pt>
                <c:pt idx="22">
                  <c:v>646.16984138528369</c:v>
                </c:pt>
                <c:pt idx="23">
                  <c:v>457.21981262438266</c:v>
                </c:pt>
                <c:pt idx="24">
                  <c:v>347.75483150079009</c:v>
                </c:pt>
                <c:pt idx="25">
                  <c:v>245.69187864719348</c:v>
                </c:pt>
                <c:pt idx="26">
                  <c:v>213.32044260854178</c:v>
                </c:pt>
                <c:pt idx="27">
                  <c:v>172.81425493918405</c:v>
                </c:pt>
                <c:pt idx="28">
                  <c:v>148.38098731453894</c:v>
                </c:pt>
                <c:pt idx="29">
                  <c:v>120.85054492057266</c:v>
                </c:pt>
                <c:pt idx="30">
                  <c:v>97.707843943871325</c:v>
                </c:pt>
                <c:pt idx="31">
                  <c:v>75.700624687717408</c:v>
                </c:pt>
                <c:pt idx="32">
                  <c:v>71.586460302515391</c:v>
                </c:pt>
                <c:pt idx="33">
                  <c:v>59.454052136791937</c:v>
                </c:pt>
                <c:pt idx="34">
                  <c:v>42.070275287899406</c:v>
                </c:pt>
                <c:pt idx="35">
                  <c:v>26.445897856670609</c:v>
                </c:pt>
                <c:pt idx="36">
                  <c:v>17.876443571109348</c:v>
                </c:pt>
                <c:pt idx="37">
                  <c:v>12.432732856920843</c:v>
                </c:pt>
                <c:pt idx="38">
                  <c:v>6.0936962545593589</c:v>
                </c:pt>
                <c:pt idx="39">
                  <c:v>4.5821991220085128</c:v>
                </c:pt>
                <c:pt idx="40">
                  <c:v>2.9319051853464431</c:v>
                </c:pt>
                <c:pt idx="41">
                  <c:v>2.8616799114459295</c:v>
                </c:pt>
                <c:pt idx="42">
                  <c:v>2.176983490915922</c:v>
                </c:pt>
                <c:pt idx="43">
                  <c:v>2.1812366879124938</c:v>
                </c:pt>
                <c:pt idx="44">
                  <c:v>2.1257453943793534</c:v>
                </c:pt>
                <c:pt idx="45">
                  <c:v>1.8446550942961333</c:v>
                </c:pt>
                <c:pt idx="46">
                  <c:v>1.3527470691504977</c:v>
                </c:pt>
                <c:pt idx="47">
                  <c:v>1.9048654282478261</c:v>
                </c:pt>
                <c:pt idx="48">
                  <c:v>2.0938646071953984</c:v>
                </c:pt>
                <c:pt idx="49">
                  <c:v>1.6363815837745552</c:v>
                </c:pt>
                <c:pt idx="50">
                  <c:v>1.8475275945841754</c:v>
                </c:pt>
                <c:pt idx="51">
                  <c:v>2.44577462521143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E7-401C-BB7E-AC7C81D39D21}"/>
            </c:ext>
          </c:extLst>
        </c:ser>
        <c:ser>
          <c:idx val="2"/>
          <c:order val="2"/>
          <c:tx>
            <c:strRef>
              <c:f>'P9 分母調整した発生割合_Fig1S'!$J$12</c:f>
              <c:strCache>
                <c:ptCount val="1"/>
                <c:pt idx="0">
                  <c:v>処方のみ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P9 分母調整した発生割合_Fig1S'!$K$12:$BJ$12</c:f>
              <c:numCache>
                <c:formatCode>General</c:formatCode>
                <c:ptCount val="52"/>
                <c:pt idx="0">
                  <c:v>6.2189634853558953E-2</c:v>
                </c:pt>
                <c:pt idx="1">
                  <c:v>0.20729878284519651</c:v>
                </c:pt>
                <c:pt idx="2">
                  <c:v>0.18656890456067687</c:v>
                </c:pt>
                <c:pt idx="3">
                  <c:v>8.2919513138078604E-2</c:v>
                </c:pt>
                <c:pt idx="4">
                  <c:v>0.47242836188751969</c:v>
                </c:pt>
                <c:pt idx="5">
                  <c:v>0.26907609823926948</c:v>
                </c:pt>
                <c:pt idx="6">
                  <c:v>0.45535955086645608</c:v>
                </c:pt>
                <c:pt idx="7">
                  <c:v>0.51745403507551824</c:v>
                </c:pt>
                <c:pt idx="8">
                  <c:v>0.78248356990419921</c:v>
                </c:pt>
                <c:pt idx="9">
                  <c:v>1.3655701689955155</c:v>
                </c:pt>
                <c:pt idx="10">
                  <c:v>1.9242125108573174</c:v>
                </c:pt>
                <c:pt idx="11">
                  <c:v>2.917354451944965</c:v>
                </c:pt>
                <c:pt idx="12">
                  <c:v>3.4791853106737496</c:v>
                </c:pt>
                <c:pt idx="13">
                  <c:v>5.2085809303931034</c:v>
                </c:pt>
                <c:pt idx="14">
                  <c:v>6.0353398082332781</c:v>
                </c:pt>
                <c:pt idx="15">
                  <c:v>12.070679616466556</c:v>
                </c:pt>
                <c:pt idx="16">
                  <c:v>17.754646901617757</c:v>
                </c:pt>
                <c:pt idx="17">
                  <c:v>14.202907546882441</c:v>
                </c:pt>
                <c:pt idx="18">
                  <c:v>25.424480301918802</c:v>
                </c:pt>
                <c:pt idx="19">
                  <c:v>37.206556539393368</c:v>
                </c:pt>
                <c:pt idx="20">
                  <c:v>57.339437689042896</c:v>
                </c:pt>
                <c:pt idx="21">
                  <c:v>65.315403292291052</c:v>
                </c:pt>
                <c:pt idx="22">
                  <c:v>49.153867514727565</c:v>
                </c:pt>
                <c:pt idx="23">
                  <c:v>35.165986763373816</c:v>
                </c:pt>
                <c:pt idx="24">
                  <c:v>26.632759658042804</c:v>
                </c:pt>
                <c:pt idx="25">
                  <c:v>20.271141632008252</c:v>
                </c:pt>
                <c:pt idx="26">
                  <c:v>16.113405989409689</c:v>
                </c:pt>
                <c:pt idx="27">
                  <c:v>13.481819584104086</c:v>
                </c:pt>
                <c:pt idx="28">
                  <c:v>12.388699077284834</c:v>
                </c:pt>
                <c:pt idx="29">
                  <c:v>9.6154118655397003</c:v>
                </c:pt>
                <c:pt idx="30">
                  <c:v>7.8879621295508615</c:v>
                </c:pt>
                <c:pt idx="31">
                  <c:v>6.3375638614601533</c:v>
                </c:pt>
                <c:pt idx="32">
                  <c:v>5.3571672420077547</c:v>
                </c:pt>
                <c:pt idx="33">
                  <c:v>4.7969406023206691</c:v>
                </c:pt>
                <c:pt idx="34">
                  <c:v>3.1678899885799305</c:v>
                </c:pt>
                <c:pt idx="35">
                  <c:v>2.3530878571008378</c:v>
                </c:pt>
                <c:pt idx="36">
                  <c:v>1.2467853571205931</c:v>
                </c:pt>
                <c:pt idx="37">
                  <c:v>1.0360610714100704</c:v>
                </c:pt>
                <c:pt idx="38">
                  <c:v>0.55873432706561454</c:v>
                </c:pt>
                <c:pt idx="39">
                  <c:v>0.33357005102743964</c:v>
                </c:pt>
                <c:pt idx="40">
                  <c:v>0.26334477712692606</c:v>
                </c:pt>
                <c:pt idx="41">
                  <c:v>0.17556318475128402</c:v>
                </c:pt>
                <c:pt idx="42">
                  <c:v>8.7781592375642009E-2</c:v>
                </c:pt>
                <c:pt idx="43">
                  <c:v>8.7249467516499743E-2</c:v>
                </c:pt>
                <c:pt idx="44">
                  <c:v>8.7840718776006341E-2</c:v>
                </c:pt>
                <c:pt idx="45">
                  <c:v>0.15811329379681141</c:v>
                </c:pt>
                <c:pt idx="46">
                  <c:v>0.15811329379681141</c:v>
                </c:pt>
                <c:pt idx="47">
                  <c:v>0.22718578502038292</c:v>
                </c:pt>
                <c:pt idx="48">
                  <c:v>0.19355050990881836</c:v>
                </c:pt>
                <c:pt idx="49">
                  <c:v>0.17595500900801669</c:v>
                </c:pt>
                <c:pt idx="50">
                  <c:v>0.22874151171042167</c:v>
                </c:pt>
                <c:pt idx="51">
                  <c:v>0.334314517115231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1E7-401C-BB7E-AC7C81D39D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overlap val="100"/>
        <c:axId val="887255912"/>
        <c:axId val="887257224"/>
      </c:barChart>
      <c:catAx>
        <c:axId val="887255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 Unicode MS" panose="020B0604020202020204" pitchFamily="34" charset="-128"/>
                    <a:ea typeface="+mn-ea"/>
                    <a:cs typeface="+mn-cs"/>
                  </a:defRPr>
                </a:pPr>
                <a:r>
                  <a:rPr lang="en-US" altLang="ja-JP" sz="900" baseline="0">
                    <a:solidFill>
                      <a:schemeClr val="tx1"/>
                    </a:solidFill>
                    <a:latin typeface="Arial Unicode MS" panose="020B0604020202020204" pitchFamily="34" charset="-128"/>
                  </a:rPr>
                  <a:t>Weeks in 2016/17</a:t>
                </a:r>
                <a:endParaRPr lang="ja-JP" altLang="en-US" sz="900" baseline="0">
                  <a:solidFill>
                    <a:schemeClr val="tx1"/>
                  </a:solidFill>
                  <a:latin typeface="Arial Unicode MS" panose="020B0604020202020204" pitchFamily="34" charset="-128"/>
                </a:endParaRPr>
              </a:p>
            </c:rich>
          </c:tx>
          <c:layout>
            <c:manualLayout>
              <c:xMode val="edge"/>
              <c:yMode val="edge"/>
              <c:x val="0.41304135802469139"/>
              <c:y val="0.919310980614068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 Unicode MS" panose="020B0604020202020204" pitchFamily="34" charset="-128"/>
                  <a:ea typeface="+mn-ea"/>
                  <a:cs typeface="+mn-cs"/>
                </a:defRPr>
              </a:pPr>
              <a:endParaRPr lang="ja-JP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887257224"/>
        <c:crosses val="autoZero"/>
        <c:auto val="1"/>
        <c:lblAlgn val="ctr"/>
        <c:lblOffset val="100"/>
        <c:noMultiLvlLbl val="0"/>
      </c:catAx>
      <c:valAx>
        <c:axId val="887257224"/>
        <c:scaling>
          <c:orientation val="minMax"/>
          <c:max val="25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 Unicode MS" panose="020B0604020202020204" pitchFamily="34" charset="-128"/>
                    <a:ea typeface="+mn-ea"/>
                    <a:cs typeface="+mn-cs"/>
                  </a:defRPr>
                </a:pPr>
                <a:r>
                  <a:rPr lang="en-US" altLang="ja-JP" sz="900" baseline="0">
                    <a:solidFill>
                      <a:schemeClr val="tx1"/>
                    </a:solidFill>
                    <a:latin typeface="Arial Unicode MS" panose="020B0604020202020204" pitchFamily="34" charset="-128"/>
                  </a:rPr>
                  <a:t>Number of patients in 100,000 people</a:t>
                </a:r>
                <a:endParaRPr lang="ja-JP" altLang="en-US" sz="900" baseline="0">
                  <a:solidFill>
                    <a:schemeClr val="tx1"/>
                  </a:solidFill>
                  <a:latin typeface="Arial Unicode MS" panose="020B0604020202020204" pitchFamily="34" charset="-128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 Unicode MS" panose="020B0604020202020204" pitchFamily="34" charset="-128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887255912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329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968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633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100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908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294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0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106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375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12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122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08850-9341-4E4D-946A-83990776D822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2DD6F-15A0-4C89-83AA-75BDC54F3E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08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68BA796F-946F-AF4D-98BE-B67F809210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3812139"/>
              </p:ext>
            </p:extLst>
          </p:nvPr>
        </p:nvGraphicFramePr>
        <p:xfrm>
          <a:off x="3467100" y="1557207"/>
          <a:ext cx="3240000" cy="26684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C798D25D-8E83-584D-9656-F5092D1BD9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542621"/>
              </p:ext>
            </p:extLst>
          </p:nvPr>
        </p:nvGraphicFramePr>
        <p:xfrm>
          <a:off x="152330" y="4650803"/>
          <a:ext cx="3240000" cy="26228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5F3FEDEE-7E39-D34B-89ED-31C0A221CC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0440349"/>
              </p:ext>
            </p:extLst>
          </p:nvPr>
        </p:nvGraphicFramePr>
        <p:xfrm>
          <a:off x="3467100" y="4650803"/>
          <a:ext cx="3240000" cy="26228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514DD41C-01E5-EC4C-9226-2FD18B4B66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1406423"/>
              </p:ext>
            </p:extLst>
          </p:nvPr>
        </p:nvGraphicFramePr>
        <p:xfrm>
          <a:off x="152330" y="1557207"/>
          <a:ext cx="3240000" cy="26684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152330" y="180975"/>
            <a:ext cx="20104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information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52331" y="605146"/>
            <a:ext cx="6554770" cy="6426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atients receiving either test or prescription for influenza on a weekly basis by season (2016/17–2019/20 season). Each season lasted from September 1 of a current year until August 31 of the following year.</a:t>
            </a:r>
          </a:p>
        </p:txBody>
      </p:sp>
    </p:spTree>
    <p:extLst>
      <p:ext uri="{BB962C8B-B14F-4D97-AF65-F5344CB8AC3E}">
        <p14:creationId xmlns:p14="http://schemas.microsoft.com/office/powerpoint/2010/main" val="788294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78</Words>
  <Application>Microsoft Office PowerPoint</Application>
  <PresentationFormat>A4 210 x 297 mm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Arial Unicode MS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mi Takeshima</dc:creator>
  <cp:lastModifiedBy>Tomomi Takeshima</cp:lastModifiedBy>
  <cp:revision>5</cp:revision>
  <dcterms:created xsi:type="dcterms:W3CDTF">2022-02-05T08:28:00Z</dcterms:created>
  <dcterms:modified xsi:type="dcterms:W3CDTF">2022-02-22T06:02:00Z</dcterms:modified>
</cp:coreProperties>
</file>